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7"/>
    <p:restoredTop sz="94614"/>
  </p:normalViewPr>
  <p:slideViewPr>
    <p:cSldViewPr snapToGrid="0" snapToObjects="1">
      <p:cViewPr varScale="1">
        <p:scale>
          <a:sx n="113" d="100"/>
          <a:sy n="113" d="100"/>
        </p:scale>
        <p:origin x="208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56D25B-813C-564E-A27F-B6550CB9F26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415FF9-C808-6E48-A09C-F6E39543FB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300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89E025-F927-CC4C-98E6-7CC2418F237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235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FF8A36-8584-F54E-943E-93FC43CE22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626EA57-ACA7-3444-97F4-DFE72F2A84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625023-37F2-2541-BC30-16F7783B2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9BBB5A-A61D-AF41-B51D-BDE2C153D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D3DF90-0651-684A-BF75-5ED13F2BE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2509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E85B71-95B2-A845-951A-B47B39A8D1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4A1491-6D99-9F41-97F3-92423517DD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61B717-9E86-B049-B97F-6A2061D3E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B2F484-56A4-4D44-A23C-9BE404BDB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94B64A-A3E2-4C44-8E85-8E35B8DC1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775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7C4C511-EEDF-CE48-A0BE-78D83AC029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C23B66-9263-9C43-B75D-BF80BC94D0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8F160B-F446-9D47-BE46-158681576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4735DE-0F5A-8146-AE8B-96B6E3263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C92297-7399-E246-9131-EA5E331DA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082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03D92E-9461-CF44-994A-69B834E6A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8C2396-B574-454D-BF0E-531540C041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2EB043-DB41-FD4A-9866-A767C5CE6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890725-068D-2D44-B96F-068073799C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5D873F-B68C-2E46-B078-419065E5A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283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BFB889-CBE9-2940-A448-11E8BE8DBF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CD3ED0-C3F8-7342-BE34-17F24D46F3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6237BA-3880-5E48-95C4-F3D234E6A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9F16A4-94A2-0E42-B7AF-161BBB94EE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38C543-C8B6-9E40-B15A-666F0CB81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5860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3EA112-4E9C-9F46-ABCE-7B64451D67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2CD708-A6F0-4A45-9AEF-228C27E734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BA0125-498F-FC49-BABD-7172BE7A4E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C90EB0-E931-4046-8A78-0C4427E0A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D31919-90D2-5747-8CB8-A207CBCF3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0CCE49-2DC3-AD40-9671-391C59E1A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608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33096B-70E2-6B4B-9677-2454F79251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C800F9-A38E-CD4A-B425-1263CD232A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27501A-1764-E345-A3E8-5B61A83463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3D815D-89D8-6848-9001-2F1BDCC97E1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D9D9F1-7CC6-F249-9E1B-452BB8DC65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00C776-A1F9-254D-8FD9-A3EBB0C569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3A7D76D-E79F-BA4F-8F9D-0898C236C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5D2953B-63CD-3242-937C-1BED45A2A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947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8A70E7-DA76-2B4E-AA5B-D0B1FC3C1A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6A4BB1D-C23F-EF44-8F1E-7D92D3E32C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6D9D4D-4422-4649-96BF-E60DB4C736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9E51432-7D57-3540-B57F-7A11264F2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676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763F8FC-D9B6-3A4B-9965-F5BF56EA8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BCD8F9-939A-7C47-9A62-BE2B44D77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1D8B3B-6AAB-BC47-AAAE-02C667CB2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04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222A9C-BE95-4D40-B087-EDA3D1982D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8B34ED-57B8-8E4F-A922-4A214035CF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70333B-4F85-BA48-8E3D-FD3679F2E6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92CB42-C2B3-E749-A2E4-E27776FCFF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B072D1-2F4D-A340-991D-97AA15DA3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47E51D-D94D-5348-9451-220F4AA5A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180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D7A83C-81B8-9C4C-A487-4BCFFA4A63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CE9E55F-8798-AB40-8063-0428FCB2F9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D0518C-9AB5-B540-A8EE-ABAC89FF37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65E032-4041-0C45-BC75-8F28B7FFA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6874EB-919A-5A41-9668-DBB963F87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F72CA7-CA76-A946-802C-8C01506AD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244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09ABF1-AC45-E149-8DDB-BAE7D0E6C4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2834AB-EFEB-144A-8D34-0B434303D2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71420F-96A5-1748-AB23-9FAB58D6F4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3DF717-F568-FB46-814C-6185591F621A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E6AE29-B5C1-D246-A521-CED916F13E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DB4850-169D-7540-A217-4E30481828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9C6E84-D6DD-3A4F-819A-E919C73ED8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818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/>
          <p:cNvSpPr>
            <a:spLocks noGrp="1"/>
          </p:cNvSpPr>
          <p:nvPr>
            <p:ph type="title"/>
          </p:nvPr>
        </p:nvSpPr>
        <p:spPr>
          <a:xfrm>
            <a:off x="0" y="216999"/>
            <a:ext cx="8907164" cy="677733"/>
          </a:xfrm>
        </p:spPr>
        <p:txBody>
          <a:bodyPr>
            <a:noAutofit/>
          </a:bodyPr>
          <a:lstStyle/>
          <a:p>
            <a:pPr algn="l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br>
              <a:rPr lang="en-CA" dirty="0"/>
            </a:br>
            <a:r>
              <a:rPr lang="en-CA" dirty="0"/>
              <a:t> </a:t>
            </a:r>
            <a:br>
              <a:rPr lang="en-CA" dirty="0"/>
            </a:b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827C99D-524B-B44A-B579-7CAC0123B883}"/>
              </a:ext>
            </a:extLst>
          </p:cNvPr>
          <p:cNvGrpSpPr/>
          <p:nvPr/>
        </p:nvGrpSpPr>
        <p:grpSpPr>
          <a:xfrm>
            <a:off x="4198792" y="347891"/>
            <a:ext cx="5337105" cy="6286158"/>
            <a:chOff x="2772733" y="644467"/>
            <a:chExt cx="6636310" cy="7441916"/>
          </a:xfrm>
        </p:grpSpPr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AAFE6B55-F040-0043-8DBB-00A317968500}"/>
                </a:ext>
              </a:extLst>
            </p:cNvPr>
            <p:cNvSpPr/>
            <p:nvPr/>
          </p:nvSpPr>
          <p:spPr>
            <a:xfrm>
              <a:off x="2772733" y="3268091"/>
              <a:ext cx="1781884" cy="8910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rgbClr val="000000"/>
                  </a:solidFill>
                </a:rPr>
                <a:t>Women who donated at least one milk sample </a:t>
              </a:r>
            </a:p>
            <a:p>
              <a:pPr algn="ctr"/>
              <a:r>
                <a:rPr lang="en-US" sz="1000" dirty="0">
                  <a:solidFill>
                    <a:srgbClr val="000000"/>
                  </a:solidFill>
                </a:rPr>
                <a:t>(n= 170)</a:t>
              </a:r>
            </a:p>
          </p:txBody>
        </p: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E4316538-B23F-E946-BD85-0A22E04168B9}"/>
                </a:ext>
              </a:extLst>
            </p:cNvPr>
            <p:cNvCxnSpPr/>
            <p:nvPr/>
          </p:nvCxnSpPr>
          <p:spPr>
            <a:xfrm>
              <a:off x="3703431" y="4159109"/>
              <a:ext cx="0" cy="420734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87FB4409-58BC-2B49-92BE-35F0ADBA4C08}"/>
                </a:ext>
              </a:extLst>
            </p:cNvPr>
            <p:cNvGrpSpPr/>
            <p:nvPr/>
          </p:nvGrpSpPr>
          <p:grpSpPr>
            <a:xfrm>
              <a:off x="2772733" y="644467"/>
              <a:ext cx="6636310" cy="7441916"/>
              <a:chOff x="2772733" y="521538"/>
              <a:chExt cx="6636310" cy="7564845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CF52A4F0-AD85-1544-AAEC-2A62D6B458B0}"/>
                  </a:ext>
                </a:extLst>
              </p:cNvPr>
              <p:cNvGrpSpPr/>
              <p:nvPr/>
            </p:nvGrpSpPr>
            <p:grpSpPr>
              <a:xfrm>
                <a:off x="2772733" y="521538"/>
                <a:ext cx="1800090" cy="7564845"/>
                <a:chOff x="2772733" y="799832"/>
                <a:chExt cx="1800090" cy="7564845"/>
              </a:xfrm>
            </p:grpSpPr>
            <p:grpSp>
              <p:nvGrpSpPr>
                <p:cNvPr id="32" name="Group 31"/>
                <p:cNvGrpSpPr/>
                <p:nvPr/>
              </p:nvGrpSpPr>
              <p:grpSpPr>
                <a:xfrm>
                  <a:off x="2772733" y="799832"/>
                  <a:ext cx="1800090" cy="6236399"/>
                  <a:chOff x="476941" y="162210"/>
                  <a:chExt cx="1800090" cy="6236399"/>
                </a:xfrm>
              </p:grpSpPr>
              <p:sp>
                <p:nvSpPr>
                  <p:cNvPr id="11" name="Rectangle 10"/>
                  <p:cNvSpPr/>
                  <p:nvPr/>
                </p:nvSpPr>
                <p:spPr>
                  <a:xfrm>
                    <a:off x="495147" y="162210"/>
                    <a:ext cx="1781884" cy="8910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dirty="0">
                        <a:solidFill>
                          <a:schemeClr val="tx1"/>
                        </a:solidFill>
                      </a:rPr>
                      <a:t>Potential pregnancies followed annually at Mount Sinai hospital</a:t>
                    </a:r>
                  </a:p>
                  <a:p>
                    <a:pPr algn="ctr"/>
                    <a:r>
                      <a:rPr lang="en-US" sz="1000" dirty="0">
                        <a:solidFill>
                          <a:schemeClr val="tx1"/>
                        </a:solidFill>
                      </a:rPr>
                      <a:t>(n= &gt;7,000)</a:t>
                    </a:r>
                  </a:p>
                </p:txBody>
              </p:sp>
              <p:sp>
                <p:nvSpPr>
                  <p:cNvPr id="14" name="Rectangle 13"/>
                  <p:cNvSpPr/>
                  <p:nvPr/>
                </p:nvSpPr>
                <p:spPr>
                  <a:xfrm>
                    <a:off x="476941" y="1499543"/>
                    <a:ext cx="1781884" cy="8910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dirty="0">
                        <a:solidFill>
                          <a:srgbClr val="000000"/>
                        </a:solidFill>
                      </a:rPr>
                      <a:t>Baseline visit completed</a:t>
                    </a:r>
                  </a:p>
                  <a:p>
                    <a:pPr algn="ctr"/>
                    <a:r>
                      <a:rPr lang="en-US" sz="1000" dirty="0">
                        <a:solidFill>
                          <a:srgbClr val="000000"/>
                        </a:solidFill>
                      </a:rPr>
                      <a:t>(n= 216)</a:t>
                    </a:r>
                  </a:p>
                </p:txBody>
              </p:sp>
              <p:sp>
                <p:nvSpPr>
                  <p:cNvPr id="17" name="Rectangle 16"/>
                  <p:cNvSpPr/>
                  <p:nvPr/>
                </p:nvSpPr>
                <p:spPr>
                  <a:xfrm>
                    <a:off x="476941" y="5507591"/>
                    <a:ext cx="1781884" cy="8910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dirty="0">
                        <a:solidFill>
                          <a:srgbClr val="000000"/>
                        </a:solidFill>
                      </a:rPr>
                      <a:t>Samples remaining for microbiota analyses </a:t>
                    </a:r>
                  </a:p>
                  <a:p>
                    <a:pPr algn="ctr"/>
                    <a:r>
                      <a:rPr lang="en-US" sz="1000" dirty="0">
                        <a:solidFill>
                          <a:srgbClr val="000000"/>
                        </a:solidFill>
                      </a:rPr>
                      <a:t>(n= 113)</a:t>
                    </a:r>
                  </a:p>
                </p:txBody>
              </p:sp>
              <p:sp>
                <p:nvSpPr>
                  <p:cNvPr id="19" name="Rectangle 18"/>
                  <p:cNvSpPr/>
                  <p:nvPr/>
                </p:nvSpPr>
                <p:spPr>
                  <a:xfrm>
                    <a:off x="476941" y="4175350"/>
                    <a:ext cx="1781884" cy="89101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000" dirty="0">
                        <a:solidFill>
                          <a:srgbClr val="000000"/>
                        </a:solidFill>
                      </a:rPr>
                      <a:t>Women who provided mature milk sample at 3 months post-partum</a:t>
                    </a:r>
                  </a:p>
                  <a:p>
                    <a:pPr algn="ctr"/>
                    <a:r>
                      <a:rPr lang="en-US" sz="1000" dirty="0">
                        <a:solidFill>
                          <a:srgbClr val="000000"/>
                        </a:solidFill>
                      </a:rPr>
                      <a:t>(n= 117)</a:t>
                    </a:r>
                  </a:p>
                </p:txBody>
              </p:sp>
              <p:cxnSp>
                <p:nvCxnSpPr>
                  <p:cNvPr id="21" name="Straight Arrow Connector 20"/>
                  <p:cNvCxnSpPr>
                    <a:cxnSpLocks/>
                    <a:stCxn id="11" idx="2"/>
                  </p:cNvCxnSpPr>
                  <p:nvPr/>
                </p:nvCxnSpPr>
                <p:spPr>
                  <a:xfrm>
                    <a:off x="1386089" y="1053228"/>
                    <a:ext cx="0" cy="45865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" name="Straight Arrow Connector 22"/>
                  <p:cNvCxnSpPr/>
                  <p:nvPr/>
                </p:nvCxnSpPr>
                <p:spPr>
                  <a:xfrm>
                    <a:off x="1370169" y="2402896"/>
                    <a:ext cx="0" cy="420734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Straight Arrow Connector 23"/>
                  <p:cNvCxnSpPr/>
                  <p:nvPr/>
                </p:nvCxnSpPr>
                <p:spPr>
                  <a:xfrm>
                    <a:off x="1386089" y="5077894"/>
                    <a:ext cx="0" cy="420734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arrow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B7B37BC4-5AF6-1940-97AF-EC163FB75609}"/>
                    </a:ext>
                  </a:extLst>
                </p:cNvPr>
                <p:cNvSpPr/>
                <p:nvPr/>
              </p:nvSpPr>
              <p:spPr>
                <a:xfrm>
                  <a:off x="2772733" y="7473659"/>
                  <a:ext cx="1781884" cy="89101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000" dirty="0">
                      <a:solidFill>
                        <a:srgbClr val="000000"/>
                      </a:solidFill>
                    </a:rPr>
                    <a:t>Samples remaining after pre-processing data (n= 109)</a:t>
                  </a:r>
                </a:p>
              </p:txBody>
            </p:sp>
            <p:cxnSp>
              <p:nvCxnSpPr>
                <p:cNvPr id="13" name="Straight Arrow Connector 12">
                  <a:extLst>
                    <a:ext uri="{FF2B5EF4-FFF2-40B4-BE49-F238E27FC236}">
                      <a16:creationId xmlns:a16="http://schemas.microsoft.com/office/drawing/2014/main" id="{DE28C608-5C06-0548-9DC4-93D4B21EEAFD}"/>
                    </a:ext>
                  </a:extLst>
                </p:cNvPr>
                <p:cNvCxnSpPr/>
                <p:nvPr/>
              </p:nvCxnSpPr>
              <p:spPr>
                <a:xfrm>
                  <a:off x="3703431" y="7039673"/>
                  <a:ext cx="0" cy="42073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8" name="Straight Arrow Connector 17">
                <a:extLst>
                  <a:ext uri="{FF2B5EF4-FFF2-40B4-BE49-F238E27FC236}">
                    <a16:creationId xmlns:a16="http://schemas.microsoft.com/office/drawing/2014/main" id="{CA640A2C-A39D-FB47-BB93-7A73ED871B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2823" y="2267321"/>
                <a:ext cx="48592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225AE1F8-5845-3342-BFD3-655E327040A1}"/>
                  </a:ext>
                </a:extLst>
              </p:cNvPr>
              <p:cNvSpPr/>
              <p:nvPr/>
            </p:nvSpPr>
            <p:spPr>
              <a:xfrm>
                <a:off x="5178002" y="1871206"/>
                <a:ext cx="1781884" cy="89101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solidFill>
                      <a:srgbClr val="000000"/>
                    </a:solidFill>
                  </a:rPr>
                  <a:t>Women who did not or could not provide a milk sample</a:t>
                </a:r>
              </a:p>
              <a:p>
                <a:pPr algn="ctr"/>
                <a:r>
                  <a:rPr lang="en-US" sz="1000" dirty="0">
                    <a:solidFill>
                      <a:srgbClr val="000000"/>
                    </a:solidFill>
                  </a:rPr>
                  <a:t>(n= 46)</a:t>
                </a:r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3A00A37F-ED52-8544-9DCE-80A47289A712}"/>
                  </a:ext>
                </a:extLst>
              </p:cNvPr>
              <p:cNvSpPr/>
              <p:nvPr/>
            </p:nvSpPr>
            <p:spPr>
              <a:xfrm>
                <a:off x="5180497" y="2955236"/>
                <a:ext cx="4228546" cy="146513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solidFill>
                    <a:srgbClr val="000000"/>
                  </a:solidFill>
                </a:endParaRPr>
              </a:p>
              <a:p>
                <a:pPr algn="ctr"/>
                <a:r>
                  <a:rPr lang="en-US" sz="1000" dirty="0">
                    <a:solidFill>
                      <a:srgbClr val="000000"/>
                    </a:solidFill>
                  </a:rPr>
                  <a:t>Women who were unable to donate a mature milk sample at 3 months post-partum (n= 35) </a:t>
                </a:r>
              </a:p>
              <a:p>
                <a:pPr algn="ctr"/>
                <a:r>
                  <a:rPr lang="en-US" sz="1000" dirty="0">
                    <a:solidFill>
                      <a:srgbClr val="000000"/>
                    </a:solidFill>
                  </a:rPr>
                  <a:t>Women who did not donate due to breastfeeding discontinuation (n= 14)</a:t>
                </a:r>
              </a:p>
              <a:p>
                <a:pPr algn="ctr"/>
                <a:r>
                  <a:rPr lang="en-US" sz="1000" dirty="0">
                    <a:solidFill>
                      <a:srgbClr val="000000"/>
                    </a:solidFill>
                  </a:rPr>
                  <a:t>Women who declined to provide a sample but continued breastfeeding (n= 4)</a:t>
                </a:r>
              </a:p>
              <a:p>
                <a:pPr algn="ctr"/>
                <a:endParaRPr lang="en-US" sz="1200" dirty="0">
                  <a:solidFill>
                    <a:srgbClr val="000000"/>
                  </a:solidFill>
                </a:endParaRPr>
              </a:p>
            </p:txBody>
          </p:sp>
          <p:cxnSp>
            <p:nvCxnSpPr>
              <p:cNvPr id="27" name="Straight Arrow Connector 26">
                <a:extLst>
                  <a:ext uri="{FF2B5EF4-FFF2-40B4-BE49-F238E27FC236}">
                    <a16:creationId xmlns:a16="http://schemas.microsoft.com/office/drawing/2014/main" id="{3D953E80-BFA6-BB44-BFB6-BA019AAF56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2823" y="3627144"/>
                <a:ext cx="48592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FB47CE13-811A-744B-B5CD-B8C13D01A2A4}"/>
                  </a:ext>
                </a:extLst>
              </p:cNvPr>
              <p:cNvSpPr/>
              <p:nvPr/>
            </p:nvSpPr>
            <p:spPr>
              <a:xfrm>
                <a:off x="5178002" y="4526385"/>
                <a:ext cx="1781884" cy="89101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solidFill>
                      <a:srgbClr val="000000"/>
                    </a:solidFill>
                  </a:rPr>
                  <a:t>Milk samples with inadequate volume </a:t>
                </a:r>
              </a:p>
              <a:p>
                <a:pPr algn="ctr"/>
                <a:r>
                  <a:rPr lang="en-US" sz="1000" dirty="0">
                    <a:solidFill>
                      <a:srgbClr val="000000"/>
                    </a:solidFill>
                  </a:rPr>
                  <a:t>(n= 4)</a:t>
                </a:r>
              </a:p>
            </p:txBody>
          </p:sp>
          <p:cxnSp>
            <p:nvCxnSpPr>
              <p:cNvPr id="29" name="Straight Arrow Connector 28">
                <a:extLst>
                  <a:ext uri="{FF2B5EF4-FFF2-40B4-BE49-F238E27FC236}">
                    <a16:creationId xmlns:a16="http://schemas.microsoft.com/office/drawing/2014/main" id="{FCBA1DBD-4834-8745-89C8-13C39C547E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2823" y="4966467"/>
                <a:ext cx="48592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8281EFD8-AF45-604B-8EE3-C2D9F7732FEB}"/>
                  </a:ext>
                </a:extLst>
              </p:cNvPr>
              <p:cNvSpPr/>
              <p:nvPr/>
            </p:nvSpPr>
            <p:spPr>
              <a:xfrm>
                <a:off x="5178002" y="5866919"/>
                <a:ext cx="1781884" cy="89101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000" dirty="0">
                    <a:solidFill>
                      <a:srgbClr val="000000"/>
                    </a:solidFill>
                  </a:rPr>
                  <a:t>Samples removed due to </a:t>
                </a:r>
                <a:r>
                  <a:rPr lang="en-US" sz="1000">
                    <a:solidFill>
                      <a:srgbClr val="000000"/>
                    </a:solidFill>
                  </a:rPr>
                  <a:t>low read </a:t>
                </a:r>
                <a:r>
                  <a:rPr lang="en-US" sz="1000" dirty="0">
                    <a:solidFill>
                      <a:srgbClr val="000000"/>
                    </a:solidFill>
                  </a:rPr>
                  <a:t>counts</a:t>
                </a:r>
              </a:p>
              <a:p>
                <a:pPr algn="ctr"/>
                <a:r>
                  <a:rPr lang="en-US" sz="1000" dirty="0">
                    <a:solidFill>
                      <a:srgbClr val="000000"/>
                    </a:solidFill>
                  </a:rPr>
                  <a:t>(n= 4)</a:t>
                </a:r>
              </a:p>
            </p:txBody>
          </p:sp>
          <p:cxnSp>
            <p:nvCxnSpPr>
              <p:cNvPr id="33" name="Straight Arrow Connector 32">
                <a:extLst>
                  <a:ext uri="{FF2B5EF4-FFF2-40B4-BE49-F238E27FC236}">
                    <a16:creationId xmlns:a16="http://schemas.microsoft.com/office/drawing/2014/main" id="{F39B7924-EDD9-4342-8863-7F1EBC7F14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2823" y="6312428"/>
                <a:ext cx="48592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056875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6</TotalTime>
  <Words>160</Words>
  <Application>Microsoft Macintosh PowerPoint</Application>
  <PresentationFormat>Widescreen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Figure S6.    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6. Flow diagram of subject participation at each time point   </dc:title>
  <dc:creator>Lauren LeMay</dc:creator>
  <cp:lastModifiedBy>Lauren LeMay</cp:lastModifiedBy>
  <cp:revision>13</cp:revision>
  <dcterms:created xsi:type="dcterms:W3CDTF">2020-06-27T17:56:21Z</dcterms:created>
  <dcterms:modified xsi:type="dcterms:W3CDTF">2020-07-10T21:46:15Z</dcterms:modified>
</cp:coreProperties>
</file>